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inimized">
    <p:restoredLeft sz="15620"/>
    <p:restoredTop sz="94660"/>
  </p:normalViewPr>
  <p:slideViewPr>
    <p:cSldViewPr>
      <p:cViewPr varScale="1">
        <p:scale>
          <a:sx n="95" d="100"/>
          <a:sy n="95" d="100"/>
        </p:scale>
        <p:origin x="-114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B602B-8547-4E2F-AE8A-3BA8762D2013}" type="datetimeFigureOut">
              <a:rPr lang="es-ES" smtClean="0"/>
              <a:pPr/>
              <a:t>14/06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2C776-3466-4ECD-8556-69DE0A5E33C6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143108" y="142873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Promoters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6084032" y="142873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CGI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Agustín\Documents\IUOPA\PROYECTOS LAB INTERNOS\AESTELA\5hmC\PAPER\2016\JTM\RV1\hidroxy\HidroxyAging-2016-05-27-13-51-55\figures\venn_rev\venn_rev.island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798148" y="1857364"/>
            <a:ext cx="3060000" cy="3060000"/>
          </a:xfrm>
          <a:prstGeom prst="rect">
            <a:avLst/>
          </a:prstGeom>
          <a:noFill/>
        </p:spPr>
      </p:pic>
      <p:pic>
        <p:nvPicPr>
          <p:cNvPr id="1027" name="Picture 3" descr="C:\Users\Agustín\Documents\IUOPA\PROYECTOS LAB INTERNOS\AESTELA\5hmC\PAPER\2016\JTM\RV1\hidroxy\HidroxyAging-2016-05-27-13-51-55\figures\venn_rev\venn_rev.promote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54810" y="1928802"/>
            <a:ext cx="3060000" cy="3060000"/>
          </a:xfrm>
          <a:prstGeom prst="rect">
            <a:avLst/>
          </a:prstGeom>
          <a:noFill/>
        </p:spPr>
      </p:pic>
      <p:sp>
        <p:nvSpPr>
          <p:cNvPr id="8" name="7 CuadroTexto"/>
          <p:cNvSpPr txBox="1"/>
          <p:nvPr/>
        </p:nvSpPr>
        <p:spPr>
          <a:xfrm>
            <a:off x="8257219" y="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428596" y="5786454"/>
            <a:ext cx="828680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S1.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Venn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diagram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showing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overlap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of 5mC and 5hmC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differentially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hyper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- and hypohydroxymethylated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CpG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sites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at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promoters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left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panel), and in 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CGIs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s-ES" sz="1100" dirty="0" err="1" smtClean="0">
                <a:latin typeface="Arial" pitchFamily="34" charset="0"/>
                <a:cs typeface="Arial" pitchFamily="34" charset="0"/>
              </a:rPr>
              <a:t>right</a:t>
            </a:r>
            <a:r>
              <a:rPr lang="es-ES" sz="1100" dirty="0" smtClean="0">
                <a:latin typeface="Arial" pitchFamily="34" charset="0"/>
                <a:cs typeface="Arial" pitchFamily="34" charset="0"/>
              </a:rPr>
              <a:t> panel).</a:t>
            </a:r>
            <a:endParaRPr lang="es-ES" sz="11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5</Words>
  <Application>Microsoft Office PowerPoint</Application>
  <PresentationFormat>Presentación en pantalla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gustín</dc:creator>
  <cp:lastModifiedBy>Agustín</cp:lastModifiedBy>
  <cp:revision>6</cp:revision>
  <dcterms:created xsi:type="dcterms:W3CDTF">2016-06-08T13:31:14Z</dcterms:created>
  <dcterms:modified xsi:type="dcterms:W3CDTF">2016-06-14T12:01:54Z</dcterms:modified>
</cp:coreProperties>
</file>